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74311" autoAdjust="0"/>
  </p:normalViewPr>
  <p:slideViewPr>
    <p:cSldViewPr snapToGrid="0">
      <p:cViewPr varScale="1">
        <p:scale>
          <a:sx n="79" d="100"/>
          <a:sy n="79" d="100"/>
        </p:scale>
        <p:origin x="183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63169-6673-4D2B-BD08-C7F971471772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5829A3-4160-47FF-A4A1-C516B46390BE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78088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5829A3-4160-47FF-A4A1-C516B46390BE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75325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81804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04627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45698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76764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62303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48790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10383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9317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65572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5153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75728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7234D-1146-4C46-BA68-1353755A9E47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1F88C-701C-4D70-8136-035E475F3F3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84366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/>
          <p:cNvSpPr txBox="1"/>
          <p:nvPr/>
        </p:nvSpPr>
        <p:spPr>
          <a:xfrm>
            <a:off x="429553" y="1522858"/>
            <a:ext cx="1248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 err="1"/>
              <a:t>Cyt</a:t>
            </a:r>
            <a:r>
              <a:rPr lang="es-MX" sz="1400" b="1" dirty="0"/>
              <a:t>-C (14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3"/>
          <a:srcRect b="5695"/>
          <a:stretch/>
        </p:blipFill>
        <p:spPr>
          <a:xfrm flipH="1">
            <a:off x="2254185" y="163721"/>
            <a:ext cx="2957019" cy="1692886"/>
          </a:xfrm>
          <a:prstGeom prst="rect">
            <a:avLst/>
          </a:prstGeom>
        </p:spPr>
      </p:pic>
      <p:grpSp>
        <p:nvGrpSpPr>
          <p:cNvPr id="25" name="Grupo 24"/>
          <p:cNvGrpSpPr/>
          <p:nvPr/>
        </p:nvGrpSpPr>
        <p:grpSpPr>
          <a:xfrm>
            <a:off x="1866163" y="419899"/>
            <a:ext cx="435111" cy="1355320"/>
            <a:chOff x="1117683" y="905016"/>
            <a:chExt cx="435111" cy="1355320"/>
          </a:xfrm>
        </p:grpSpPr>
        <p:sp>
          <p:nvSpPr>
            <p:cNvPr id="26" name="CuadroTexto 25"/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grpSp>
        <p:nvGrpSpPr>
          <p:cNvPr id="41" name="Grupo 40"/>
          <p:cNvGrpSpPr/>
          <p:nvPr/>
        </p:nvGrpSpPr>
        <p:grpSpPr>
          <a:xfrm>
            <a:off x="2329555" y="1853685"/>
            <a:ext cx="2933149" cy="864383"/>
            <a:chOff x="1488024" y="2443042"/>
            <a:chExt cx="2933149" cy="864383"/>
          </a:xfrm>
        </p:grpSpPr>
        <p:sp>
          <p:nvSpPr>
            <p:cNvPr id="42" name="CuadroTexto 41"/>
            <p:cNvSpPr txBox="1"/>
            <p:nvPr/>
          </p:nvSpPr>
          <p:spPr>
            <a:xfrm rot="5400000">
              <a:off x="1615009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43" name="CuadroTexto 42"/>
            <p:cNvSpPr txBox="1"/>
            <p:nvPr/>
          </p:nvSpPr>
          <p:spPr>
            <a:xfrm rot="5400000">
              <a:off x="2541948" y="2316057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44" name="CuadroTexto 43"/>
            <p:cNvSpPr txBox="1"/>
            <p:nvPr/>
          </p:nvSpPr>
          <p:spPr>
            <a:xfrm rot="5400000">
              <a:off x="3486329" y="236184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</p:txBody>
        </p:sp>
      </p:grpSp>
      <p:sp>
        <p:nvSpPr>
          <p:cNvPr id="45" name="CuadroTexto 44"/>
          <p:cNvSpPr txBox="1"/>
          <p:nvPr/>
        </p:nvSpPr>
        <p:spPr>
          <a:xfrm>
            <a:off x="5607427" y="1175024"/>
            <a:ext cx="1248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/>
              <a:t>Bcl-2 (26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46" name="Imagen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8377" y="192008"/>
            <a:ext cx="2954698" cy="1691587"/>
          </a:xfrm>
          <a:prstGeom prst="rect">
            <a:avLst/>
          </a:prstGeom>
        </p:spPr>
      </p:pic>
      <p:grpSp>
        <p:nvGrpSpPr>
          <p:cNvPr id="47" name="Grupo 46"/>
          <p:cNvGrpSpPr/>
          <p:nvPr/>
        </p:nvGrpSpPr>
        <p:grpSpPr>
          <a:xfrm>
            <a:off x="6979585" y="488801"/>
            <a:ext cx="435111" cy="1355320"/>
            <a:chOff x="1117683" y="905016"/>
            <a:chExt cx="435111" cy="1355320"/>
          </a:xfrm>
        </p:grpSpPr>
        <p:sp>
          <p:nvSpPr>
            <p:cNvPr id="48" name="CuadroTexto 47"/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grpSp>
        <p:nvGrpSpPr>
          <p:cNvPr id="55" name="Grupo 54"/>
          <p:cNvGrpSpPr/>
          <p:nvPr/>
        </p:nvGrpSpPr>
        <p:grpSpPr>
          <a:xfrm>
            <a:off x="7293364" y="1844121"/>
            <a:ext cx="2961430" cy="864383"/>
            <a:chOff x="1459743" y="2443042"/>
            <a:chExt cx="2961430" cy="864383"/>
          </a:xfrm>
        </p:grpSpPr>
        <p:sp>
          <p:nvSpPr>
            <p:cNvPr id="56" name="CuadroTexto 55"/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57" name="CuadroTexto 56"/>
            <p:cNvSpPr txBox="1"/>
            <p:nvPr/>
          </p:nvSpPr>
          <p:spPr>
            <a:xfrm rot="5400000">
              <a:off x="2523094" y="2316057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58" name="CuadroTexto 57"/>
            <p:cNvSpPr txBox="1"/>
            <p:nvPr/>
          </p:nvSpPr>
          <p:spPr>
            <a:xfrm rot="5400000">
              <a:off x="3486329" y="236184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 ZnO NPs</a:t>
              </a:r>
            </a:p>
          </p:txBody>
        </p:sp>
      </p:grpSp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id="{2BEB810A-8387-3392-1E51-30AC4F12A698}"/>
              </a:ext>
            </a:extLst>
          </p:cNvPr>
          <p:cNvCxnSpPr/>
          <p:nvPr/>
        </p:nvCxnSpPr>
        <p:spPr>
          <a:xfrm>
            <a:off x="1677578" y="1695850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60A52BEB-9640-E788-4E01-48089A4844A2}"/>
              </a:ext>
            </a:extLst>
          </p:cNvPr>
          <p:cNvCxnSpPr/>
          <p:nvPr/>
        </p:nvCxnSpPr>
        <p:spPr>
          <a:xfrm>
            <a:off x="6795090" y="1331594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ángulo 69">
            <a:extLst>
              <a:ext uri="{FF2B5EF4-FFF2-40B4-BE49-F238E27FC236}">
                <a16:creationId xmlns:a16="http://schemas.microsoft.com/office/drawing/2014/main" id="{0EC6A36E-1869-FDBD-C7A8-3D876A1F02B3}"/>
              </a:ext>
            </a:extLst>
          </p:cNvPr>
          <p:cNvSpPr/>
          <p:nvPr/>
        </p:nvSpPr>
        <p:spPr>
          <a:xfrm>
            <a:off x="58086" y="5691173"/>
            <a:ext cx="1207582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Figure 2. Original blots without cuts and with the molecular weight corresponding to 15, 25, 37, 50 and 75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The antibodies used are specific for Cyt c (14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BcL-2 (26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Caspase 3 (32KDa) and Caspase 9 (46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In each lane, the mitochondrial sample of the 3 different conditions was loaded with 3 independent experiments.</a:t>
            </a:r>
          </a:p>
          <a:p>
            <a:pPr algn="just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09D29FF4-13EA-80C5-5C7B-F84C4DE19F1F}"/>
              </a:ext>
            </a:extLst>
          </p:cNvPr>
          <p:cNvGrpSpPr/>
          <p:nvPr/>
        </p:nvGrpSpPr>
        <p:grpSpPr>
          <a:xfrm>
            <a:off x="2180916" y="4652814"/>
            <a:ext cx="2909219" cy="870910"/>
            <a:chOff x="1459743" y="2457859"/>
            <a:chExt cx="2909219" cy="870910"/>
          </a:xfrm>
        </p:grpSpPr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11791656-9F40-B869-D35F-467DF3D088C8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D99332AE-0EE1-31CF-09BB-1B64ECAB4821}"/>
                </a:ext>
              </a:extLst>
            </p:cNvPr>
            <p:cNvSpPr txBox="1"/>
            <p:nvPr/>
          </p:nvSpPr>
          <p:spPr>
            <a:xfrm rot="5400000">
              <a:off x="2527004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A3D3618C-A755-5379-5B90-EA249869B5B2}"/>
                </a:ext>
              </a:extLst>
            </p:cNvPr>
            <p:cNvSpPr txBox="1"/>
            <p:nvPr/>
          </p:nvSpPr>
          <p:spPr>
            <a:xfrm rot="5400000">
              <a:off x="3434118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</a:t>
              </a:r>
            </a:p>
          </p:txBody>
        </p:sp>
      </p:grp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2078A2A-902C-AF34-81EC-88D69847BDD0}"/>
              </a:ext>
            </a:extLst>
          </p:cNvPr>
          <p:cNvSpPr txBox="1"/>
          <p:nvPr/>
        </p:nvSpPr>
        <p:spPr>
          <a:xfrm>
            <a:off x="679710" y="3289774"/>
            <a:ext cx="1018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Caspase-3</a:t>
            </a:r>
          </a:p>
          <a:p>
            <a:pPr algn="ctr"/>
            <a:r>
              <a:rPr lang="es-MX" sz="1400" b="1" dirty="0"/>
              <a:t> (32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0C16D041-998C-854F-F39B-ED0D342CAA95}"/>
              </a:ext>
            </a:extLst>
          </p:cNvPr>
          <p:cNvCxnSpPr/>
          <p:nvPr/>
        </p:nvCxnSpPr>
        <p:spPr>
          <a:xfrm>
            <a:off x="1688796" y="3616014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upo 22">
            <a:extLst>
              <a:ext uri="{FF2B5EF4-FFF2-40B4-BE49-F238E27FC236}">
                <a16:creationId xmlns:a16="http://schemas.microsoft.com/office/drawing/2014/main" id="{F57B3C4E-D8D5-3BD8-EFE6-C94CB075257D}"/>
              </a:ext>
            </a:extLst>
          </p:cNvPr>
          <p:cNvGrpSpPr/>
          <p:nvPr/>
        </p:nvGrpSpPr>
        <p:grpSpPr>
          <a:xfrm>
            <a:off x="1916951" y="2811539"/>
            <a:ext cx="435111" cy="1432234"/>
            <a:chOff x="1117683" y="905016"/>
            <a:chExt cx="435111" cy="1432234"/>
          </a:xfrm>
        </p:grpSpPr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53D9B14A-1C3B-3A7F-C7D1-AAFC266125BE}"/>
                </a:ext>
              </a:extLst>
            </p:cNvPr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013D0B04-A3A5-215C-E9E6-64DA9A06BFE5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MX" sz="1200" dirty="0"/>
            </a:p>
            <a:p>
              <a:endParaRPr lang="es-MX" sz="1200" dirty="0"/>
            </a:p>
            <a:p>
              <a:endParaRPr lang="es-MX" sz="1200" dirty="0"/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FE801364-4411-F0DA-5740-277808577AB0}"/>
                </a:ext>
              </a:extLst>
            </p:cNvPr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6A54ADCB-5A2E-C255-31A9-9BE52B861897}"/>
                </a:ext>
              </a:extLst>
            </p:cNvPr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F9C6ED13-C470-DCA4-C2FB-0AFCE4C0539C}"/>
                </a:ext>
              </a:extLst>
            </p:cNvPr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s-MX" sz="1200" dirty="0"/>
            </a:p>
          </p:txBody>
        </p:sp>
      </p:grpSp>
      <p:pic>
        <p:nvPicPr>
          <p:cNvPr id="36" name="Imagen 35">
            <a:extLst>
              <a:ext uri="{FF2B5EF4-FFF2-40B4-BE49-F238E27FC236}">
                <a16:creationId xmlns:a16="http://schemas.microsoft.com/office/drawing/2014/main" id="{8FC03519-1180-9226-23D3-4710489293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lum bright="-5000" contrast="9000"/>
          </a:blip>
          <a:srcRect l="5879" t="4521" r="7180" b="11165"/>
          <a:stretch/>
        </p:blipFill>
        <p:spPr>
          <a:xfrm>
            <a:off x="2240602" y="2928109"/>
            <a:ext cx="2758129" cy="1840736"/>
          </a:xfrm>
          <a:prstGeom prst="rect">
            <a:avLst/>
          </a:prstGeom>
        </p:spPr>
      </p:pic>
      <p:sp>
        <p:nvSpPr>
          <p:cNvPr id="38" name="CuadroTexto 37">
            <a:extLst>
              <a:ext uri="{FF2B5EF4-FFF2-40B4-BE49-F238E27FC236}">
                <a16:creationId xmlns:a16="http://schemas.microsoft.com/office/drawing/2014/main" id="{F8988B8E-6588-6E33-A897-BCB6BF4C7EEF}"/>
              </a:ext>
            </a:extLst>
          </p:cNvPr>
          <p:cNvSpPr txBox="1"/>
          <p:nvPr/>
        </p:nvSpPr>
        <p:spPr>
          <a:xfrm>
            <a:off x="5472269" y="3347517"/>
            <a:ext cx="16790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Caspase-9</a:t>
            </a:r>
          </a:p>
          <a:p>
            <a:pPr algn="ctr"/>
            <a:r>
              <a:rPr lang="es-MX" sz="1400" b="1" dirty="0"/>
              <a:t> (46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66" name="Imagen 65">
            <a:extLst>
              <a:ext uri="{FF2B5EF4-FFF2-40B4-BE49-F238E27FC236}">
                <a16:creationId xmlns:a16="http://schemas.microsoft.com/office/drawing/2014/main" id="{C6C23C5B-229A-4367-DD41-FC58552EA6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18374" y="3085987"/>
            <a:ext cx="2903675" cy="1591334"/>
          </a:xfrm>
          <a:prstGeom prst="rect">
            <a:avLst/>
          </a:prstGeom>
        </p:spPr>
      </p:pic>
      <p:grpSp>
        <p:nvGrpSpPr>
          <p:cNvPr id="69" name="Grupo 68">
            <a:extLst>
              <a:ext uri="{FF2B5EF4-FFF2-40B4-BE49-F238E27FC236}">
                <a16:creationId xmlns:a16="http://schemas.microsoft.com/office/drawing/2014/main" id="{79422A95-9E95-BFB1-8FF9-69633DCCCC80}"/>
              </a:ext>
            </a:extLst>
          </p:cNvPr>
          <p:cNvGrpSpPr/>
          <p:nvPr/>
        </p:nvGrpSpPr>
        <p:grpSpPr>
          <a:xfrm>
            <a:off x="6940521" y="3133611"/>
            <a:ext cx="486104" cy="1339999"/>
            <a:chOff x="1095059" y="896089"/>
            <a:chExt cx="429738" cy="1300218"/>
          </a:xfrm>
        </p:grpSpPr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2669ACE6-A541-D3C6-8A35-A766C90F8618}"/>
                </a:ext>
              </a:extLst>
            </p:cNvPr>
            <p:cNvSpPr txBox="1"/>
            <p:nvPr/>
          </p:nvSpPr>
          <p:spPr>
            <a:xfrm>
              <a:off x="1120423" y="1919308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816D4C09-A6DC-C491-F789-D00B460BB8CF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8950D1DE-DF7F-4B19-F257-84A65304513D}"/>
                </a:ext>
              </a:extLst>
            </p:cNvPr>
            <p:cNvSpPr txBox="1"/>
            <p:nvPr/>
          </p:nvSpPr>
          <p:spPr>
            <a:xfrm>
              <a:off x="1123056" y="1375832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B618788A-0E38-4258-D283-BDFCF954DEBE}"/>
                </a:ext>
              </a:extLst>
            </p:cNvPr>
            <p:cNvSpPr txBox="1"/>
            <p:nvPr/>
          </p:nvSpPr>
          <p:spPr>
            <a:xfrm>
              <a:off x="1107709" y="1135081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C8DD1E33-FC9D-AB27-524E-0763EE13E7D6}"/>
                </a:ext>
              </a:extLst>
            </p:cNvPr>
            <p:cNvSpPr txBox="1"/>
            <p:nvPr/>
          </p:nvSpPr>
          <p:spPr>
            <a:xfrm>
              <a:off x="1095059" y="896089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grpSp>
        <p:nvGrpSpPr>
          <p:cNvPr id="76" name="Grupo 75">
            <a:extLst>
              <a:ext uri="{FF2B5EF4-FFF2-40B4-BE49-F238E27FC236}">
                <a16:creationId xmlns:a16="http://schemas.microsoft.com/office/drawing/2014/main" id="{4EBB28CF-8D4B-7A0E-5BAB-86D34CF399D7}"/>
              </a:ext>
            </a:extLst>
          </p:cNvPr>
          <p:cNvGrpSpPr/>
          <p:nvPr/>
        </p:nvGrpSpPr>
        <p:grpSpPr>
          <a:xfrm>
            <a:off x="7282825" y="4630325"/>
            <a:ext cx="2909219" cy="870910"/>
            <a:chOff x="1459743" y="2457859"/>
            <a:chExt cx="2909219" cy="870910"/>
          </a:xfrm>
        </p:grpSpPr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2152E860-EFED-3538-9FA1-1D5F4D8A1027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13C5F657-4C3D-4D67-2195-2A8FEDD11395}"/>
                </a:ext>
              </a:extLst>
            </p:cNvPr>
            <p:cNvSpPr txBox="1"/>
            <p:nvPr/>
          </p:nvSpPr>
          <p:spPr>
            <a:xfrm rot="5400000">
              <a:off x="2527004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0BBD5576-AA10-9FC0-DBF9-FB129FFC1981}"/>
                </a:ext>
              </a:extLst>
            </p:cNvPr>
            <p:cNvSpPr txBox="1"/>
            <p:nvPr/>
          </p:nvSpPr>
          <p:spPr>
            <a:xfrm rot="5400000">
              <a:off x="3434118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</a:t>
              </a:r>
            </a:p>
          </p:txBody>
        </p:sp>
      </p:grpSp>
      <p:cxnSp>
        <p:nvCxnSpPr>
          <p:cNvPr id="80" name="Conector recto de flecha 79">
            <a:extLst>
              <a:ext uri="{FF2B5EF4-FFF2-40B4-BE49-F238E27FC236}">
                <a16:creationId xmlns:a16="http://schemas.microsoft.com/office/drawing/2014/main" id="{67216230-7368-ED73-1002-936E3CCD70B0}"/>
              </a:ext>
            </a:extLst>
          </p:cNvPr>
          <p:cNvCxnSpPr>
            <a:cxnSpLocks/>
          </p:cNvCxnSpPr>
          <p:nvPr/>
        </p:nvCxnSpPr>
        <p:spPr>
          <a:xfrm>
            <a:off x="6770514" y="3622528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22888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4</TotalTime>
  <Words>175</Words>
  <Application>Microsoft Office PowerPoint</Application>
  <PresentationFormat>Panorámica</PresentationFormat>
  <Paragraphs>5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gie Ruiz Ramìrez</dc:creator>
  <cp:lastModifiedBy>Rebeca López</cp:lastModifiedBy>
  <cp:revision>29</cp:revision>
  <dcterms:created xsi:type="dcterms:W3CDTF">2023-05-17T15:32:22Z</dcterms:created>
  <dcterms:modified xsi:type="dcterms:W3CDTF">2023-11-13T17:40:01Z</dcterms:modified>
</cp:coreProperties>
</file>